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6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pos="2797" userDrawn="1">
          <p15:clr>
            <a:srgbClr val="A4A3A4"/>
          </p15:clr>
        </p15:guide>
        <p15:guide id="3" orient="horz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Thompson, Dorothy" initials="TD" lastIdx="1" clrIdx="0">
    <p:extLst>
      <p:ext uri="{19B8F6BF-5375-455C-9EA6-DF929625EA0E}">
        <p15:presenceInfo xmlns:p15="http://schemas.microsoft.com/office/powerpoint/2012/main" userId="S::sejjdth@ucl.ac.uk::17aa2abd-29d1-45ba-bdce-d401359b3067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9900"/>
    <a:srgbClr val="6666FF"/>
    <a:srgbClr val="FF3399"/>
    <a:srgbClr val="FFCC99"/>
    <a:srgbClr val="FF3300"/>
    <a:srgbClr val="CC0066"/>
    <a:srgbClr val="FF0066"/>
    <a:srgbClr val="FF6699"/>
    <a:srgbClr val="FF9999"/>
    <a:srgbClr val="66FF3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74" d="100"/>
          <a:sy n="74" d="100"/>
        </p:scale>
        <p:origin x="268" y="64"/>
      </p:cViewPr>
      <p:guideLst>
        <p:guide pos="2797"/>
        <p:guide orient="horz"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310585-326B-4CCE-9C24-F63F4BF76D9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A57AEF1-151A-40AA-9BF8-F3D93C49D81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5559D81-720D-46AA-8092-5D22B1F16B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FBDC70-5DCD-422D-8DC3-4624A085A281}" type="datetimeFigureOut">
              <a:rPr lang="en-GB" smtClean="0"/>
              <a:t>22/04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5A50ED2-13DF-47B4-8E76-821CDF9A2B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1E8AB9E-BA59-4A9C-9B50-1280450502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9F72B7-1291-421C-8C37-E4F86978C97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893850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0261B4-E2D2-4A82-A88A-2FA6781AAAD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F341056-D318-45FE-A85A-3BA42335848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4730E80-52A3-4449-8D78-D4F13346E2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FBDC70-5DCD-422D-8DC3-4624A085A281}" type="datetimeFigureOut">
              <a:rPr lang="en-GB" smtClean="0"/>
              <a:t>22/04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480BAF-3D8A-4D97-A481-F8ACDFB3DC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5867D7C-8146-4257-B61B-5FFD1350BE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9F72B7-1291-421C-8C37-E4F86978C97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561958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8BD3914-7116-4FB4-9EE5-FCEC662A023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05AF1E1-1243-4EF6-836C-00277CE1EA7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51E85A9-6B5C-48E9-A066-B7611816E5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FBDC70-5DCD-422D-8DC3-4624A085A281}" type="datetimeFigureOut">
              <a:rPr lang="en-GB" smtClean="0"/>
              <a:t>22/04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EAC4D4E-912F-4770-BC45-0AEF492D00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059AB72-17D1-4655-AD25-F2D57DEC7B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9F72B7-1291-421C-8C37-E4F86978C97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983853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79BE45-B12B-401A-9163-81E3E92DDF5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B18CD79-C630-41BE-9DB8-C7E5061C032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1344C43-BF76-4117-BEE4-2BA72D6002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FBDC70-5DCD-422D-8DC3-4624A085A281}" type="datetimeFigureOut">
              <a:rPr lang="en-GB" smtClean="0"/>
              <a:t>22/04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C1D2AD9-C78E-46D9-8811-C7CED0DBB4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89DF27E-C7D9-46E2-915D-2C039147A6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9F72B7-1291-421C-8C37-E4F86978C97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380735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7AACEF6-67D5-44B1-BEAA-EDE11DBD63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E19FCEB-F994-4660-8E98-2A05444DD22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06C64C1-5FA0-4028-BDF2-C5ED68903B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FBDC70-5DCD-422D-8DC3-4624A085A281}" type="datetimeFigureOut">
              <a:rPr lang="en-GB" smtClean="0"/>
              <a:t>22/04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6810D82-9DE0-4098-BD38-57CFF82E80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224B94F-8591-4027-8E91-09A23BEB25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9F72B7-1291-421C-8C37-E4F86978C97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501121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774E27-C81D-40F9-AD6B-EE1DD65959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4865DF8-E983-4A70-8935-228C7B0CB0C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F6666A4-DB2B-4CC1-AC67-3A0329244BC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A54BF95-768F-4E05-81A0-FCBFD83FE6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FBDC70-5DCD-422D-8DC3-4624A085A281}" type="datetimeFigureOut">
              <a:rPr lang="en-GB" smtClean="0"/>
              <a:t>22/04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F7F9682-3280-4847-933A-DA1FA7F4DE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FB0F4D3-23A4-4103-86DC-AC6EB26929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9F72B7-1291-421C-8C37-E4F86978C97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151936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145C63-3CB7-4831-A626-25AFFE7C17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A1A7FAE-DFD9-482E-AE2F-D81E9B16A82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3045BAB-75B5-407B-892D-B8A12107283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6DEF02F-22F2-4095-8FBC-C0AD4155BC4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0C83A11-2654-4663-B64F-A0ADE9B0545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E28F591-CE4B-4C45-B7B4-7987807ABF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FBDC70-5DCD-422D-8DC3-4624A085A281}" type="datetimeFigureOut">
              <a:rPr lang="en-GB" smtClean="0"/>
              <a:t>22/04/2021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3E28FAF-5B06-47DF-841F-282E3714AD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D41C12A-6071-4F39-9B3C-87E147406C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9F72B7-1291-421C-8C37-E4F86978C97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011044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6771C6-27C8-44DD-8D78-C6A7A4FDE67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8C303FF-3075-4C46-A003-D945EF87E3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FBDC70-5DCD-422D-8DC3-4624A085A281}" type="datetimeFigureOut">
              <a:rPr lang="en-GB" smtClean="0"/>
              <a:t>22/04/2021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179346B-0CBE-461E-92F2-6381DA16A0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87346D8-6A39-4AFF-A4D3-86FAEDCB14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9F72B7-1291-421C-8C37-E4F86978C97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126606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7FA58FD-F5EF-45AE-9475-6C208D1F4D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FBDC70-5DCD-422D-8DC3-4624A085A281}" type="datetimeFigureOut">
              <a:rPr lang="en-GB" smtClean="0"/>
              <a:t>22/04/2021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D6098FB-F393-4A8E-89CA-EA6B2D2C6A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72814B1-69D9-4CB2-8073-E3E0B9395E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9F72B7-1291-421C-8C37-E4F86978C97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769970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F588B6-59F2-414B-8E82-055AF03BF8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F208B6B-900E-4203-84A0-56DCA8C83BF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0FBD171-C010-46BA-AAC0-9A25BBB6DB8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CE01B8B-5F31-41B5-88B7-58CB92A562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FBDC70-5DCD-422D-8DC3-4624A085A281}" type="datetimeFigureOut">
              <a:rPr lang="en-GB" smtClean="0"/>
              <a:t>22/04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D811EB4-7ACA-4EEA-9639-8DD9E1B722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FA3C590-AD4C-4E2F-A43B-FC9F1E3E59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9F72B7-1291-421C-8C37-E4F86978C97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113823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AF0F269-7159-452E-9A20-50EDCE1468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EC2BE9B-5C69-4131-98C0-7EEA83A6B6A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47571FE-DEA3-468A-9271-BF8EB4774FB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2F40364-3F61-4EBD-B482-7E4C7FD60C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FBDC70-5DCD-422D-8DC3-4624A085A281}" type="datetimeFigureOut">
              <a:rPr lang="en-GB" smtClean="0"/>
              <a:t>22/04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E965214-DAC4-4317-82EE-16CF4949F0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C30ABFC-73F7-4E66-B4EC-A46C7C84AE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9F72B7-1291-421C-8C37-E4F86978C97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367823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B5F23BB-C0D2-4AB4-B157-4411C781C0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4750702-15F8-418B-9F83-37849B56F8C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85F810F-81EC-419A-B8E2-CFAD8234831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FBDC70-5DCD-422D-8DC3-4624A085A281}" type="datetimeFigureOut">
              <a:rPr lang="en-GB" smtClean="0"/>
              <a:t>22/04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F1D220E-FE95-4DCA-8AB7-E4FE7A4884F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6C2B715-46CE-4880-9D95-824EDBF7510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9F72B7-1291-421C-8C37-E4F86978C97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652077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package" Target="../embeddings/Microsoft_Excel_Worksheet.xlsx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F207B5DA-543C-416B-9CCE-1AA40DB21D17}"/>
              </a:ext>
            </a:extLst>
          </p:cNvPr>
          <p:cNvSpPr txBox="1"/>
          <p:nvPr/>
        </p:nvSpPr>
        <p:spPr>
          <a:xfrm>
            <a:off x="0" y="0"/>
            <a:ext cx="11887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ctr"/>
            <a:r>
              <a:rPr lang="en-US" dirty="0"/>
              <a:t>Appendix 3. 	</a:t>
            </a:r>
            <a:endParaRPr lang="en-GB" dirty="0"/>
          </a:p>
        </p:txBody>
      </p:sp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8AC665AE-CC89-47D7-8881-2D1069A7ED3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29170833"/>
              </p:ext>
            </p:extLst>
          </p:nvPr>
        </p:nvGraphicFramePr>
        <p:xfrm>
          <a:off x="321296" y="1072426"/>
          <a:ext cx="7338385" cy="495222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Worksheet" r:id="rId2" imgW="9842500" imgH="6642100" progId="Excel.Sheet.12">
                  <p:embed/>
                </p:oleObj>
              </mc:Choice>
              <mc:Fallback>
                <p:oleObj name="Worksheet" r:id="rId2" imgW="9842500" imgH="6642100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21296" y="1072426"/>
                        <a:ext cx="7338385" cy="4952226"/>
                      </a:xfrm>
                      <a:prstGeom prst="rect">
                        <a:avLst/>
                      </a:prstGeom>
                      <a:ln w="19050"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Table 7">
            <a:extLst>
              <a:ext uri="{FF2B5EF4-FFF2-40B4-BE49-F238E27FC236}">
                <a16:creationId xmlns:a16="http://schemas.microsoft.com/office/drawing/2014/main" id="{7A71BC50-8540-4D6D-91BF-C2907D3F4DD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52761960"/>
              </p:ext>
            </p:extLst>
          </p:nvPr>
        </p:nvGraphicFramePr>
        <p:xfrm>
          <a:off x="8726480" y="2112169"/>
          <a:ext cx="2466453" cy="143637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502187">
                  <a:extLst>
                    <a:ext uri="{9D8B030D-6E8A-4147-A177-3AD203B41FA5}">
                      <a16:colId xmlns:a16="http://schemas.microsoft.com/office/drawing/2014/main" val="2021990508"/>
                    </a:ext>
                  </a:extLst>
                </a:gridCol>
                <a:gridCol w="702733">
                  <a:extLst>
                    <a:ext uri="{9D8B030D-6E8A-4147-A177-3AD203B41FA5}">
                      <a16:colId xmlns:a16="http://schemas.microsoft.com/office/drawing/2014/main" val="3976858196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3897593500"/>
                    </a:ext>
                  </a:extLst>
                </a:gridCol>
                <a:gridCol w="651933">
                  <a:extLst>
                    <a:ext uri="{9D8B030D-6E8A-4147-A177-3AD203B41FA5}">
                      <a16:colId xmlns:a16="http://schemas.microsoft.com/office/drawing/2014/main" val="1092263379"/>
                    </a:ext>
                  </a:extLst>
                </a:gridCol>
              </a:tblGrid>
              <a:tr h="184150">
                <a:tc>
                  <a:txBody>
                    <a:bodyPr/>
                    <a:lstStyle/>
                    <a:p>
                      <a:pPr algn="ctr" fontAlgn="b"/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>
                          <a:effectLst/>
                        </a:rPr>
                        <a:t>CST</a:t>
                      </a:r>
                      <a:endParaRPr lang="en-GB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ERG</a:t>
                      </a:r>
                      <a:endParaRPr lang="en-GB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572869727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>
                          <a:effectLst/>
                        </a:rPr>
                        <a:t>CST</a:t>
                      </a:r>
                      <a:endParaRPr lang="en-GB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 dirty="0">
                          <a:effectLst/>
                        </a:rPr>
                        <a:t>Kendall Corr.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>
                          <a:effectLst/>
                        </a:rPr>
                        <a:t>1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>
                          <a:effectLst/>
                        </a:rPr>
                        <a:t>0.70877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312168992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>
                          <a:effectLst/>
                        </a:rPr>
                        <a:t>CST</a:t>
                      </a:r>
                      <a:endParaRPr lang="en-GB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 dirty="0">
                          <a:effectLst/>
                        </a:rPr>
                        <a:t>p-value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--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>
                          <a:effectLst/>
                        </a:rPr>
                        <a:t>2.80E-04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15568407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>
                          <a:effectLst/>
                        </a:rPr>
                        <a:t>ERG</a:t>
                      </a:r>
                      <a:endParaRPr lang="en-GB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 dirty="0">
                          <a:effectLst/>
                        </a:rPr>
                        <a:t>Kendall Corr.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0.7087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>
                          <a:effectLst/>
                        </a:rPr>
                        <a:t>1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140033618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>
                          <a:effectLst/>
                        </a:rPr>
                        <a:t>ERG</a:t>
                      </a:r>
                      <a:endParaRPr lang="en-GB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 dirty="0">
                          <a:effectLst/>
                        </a:rPr>
                        <a:t>p-value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2.80E-0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>
                          <a:effectLst/>
                        </a:rPr>
                        <a:t>--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674385903"/>
                  </a:ext>
                </a:extLst>
              </a:tr>
              <a:tr h="0">
                <a:tc gridSpan="4">
                  <a:txBody>
                    <a:bodyPr/>
                    <a:lstStyle/>
                    <a:p>
                      <a:pPr algn="ctr" fontAlgn="b"/>
                      <a:endParaRPr lang="en-US" sz="1100" u="none" strike="noStrike" dirty="0">
                        <a:effectLst/>
                      </a:endParaRPr>
                    </a:p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2 tailed test of significance significant correlation at the 0.05 level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454719328"/>
                  </a:ext>
                </a:extLst>
              </a:tr>
            </a:tbl>
          </a:graphicData>
        </a:graphic>
      </p:graphicFrame>
      <p:sp>
        <p:nvSpPr>
          <p:cNvPr id="9" name="TextBox 8">
            <a:extLst>
              <a:ext uri="{FF2B5EF4-FFF2-40B4-BE49-F238E27FC236}">
                <a16:creationId xmlns:a16="http://schemas.microsoft.com/office/drawing/2014/main" id="{872220DC-692C-4D39-BA6E-1369BF352C1D}"/>
              </a:ext>
            </a:extLst>
          </p:cNvPr>
          <p:cNvSpPr txBox="1"/>
          <p:nvPr/>
        </p:nvSpPr>
        <p:spPr>
          <a:xfrm>
            <a:off x="245534" y="683405"/>
            <a:ext cx="900853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ctr"/>
            <a:r>
              <a:rPr lang="en-US" sz="1100" dirty="0"/>
              <a:t>A3 a) </a:t>
            </a:r>
            <a:r>
              <a:rPr lang="en-GB" sz="1100" u="none" strike="noStrike" dirty="0">
                <a:effectLst/>
              </a:rPr>
              <a:t>right and left eye ERG amplitude and time to peak distributions are not significantly different</a:t>
            </a:r>
            <a:r>
              <a:rPr lang="en-US" sz="1100" u="none" strike="noStrike" dirty="0">
                <a:effectLst/>
              </a:rPr>
              <a:t> a</a:t>
            </a:r>
            <a:r>
              <a:rPr lang="en-US" sz="1100" dirty="0"/>
              <a:t>t</a:t>
            </a:r>
            <a:r>
              <a:rPr lang="en-GB" sz="1100" dirty="0"/>
              <a:t> the </a:t>
            </a:r>
            <a:r>
              <a:rPr lang="en-GB" sz="1100"/>
              <a:t>0.001 level</a:t>
            </a:r>
            <a:r>
              <a:rPr lang="en-GB" sz="1100" u="none" strike="noStrike">
                <a:effectLst/>
              </a:rPr>
              <a:t> </a:t>
            </a:r>
            <a:r>
              <a:rPr lang="en-GB" sz="1100" u="none" strike="noStrike" dirty="0">
                <a:effectLst/>
              </a:rPr>
              <a:t>Wilcoxon signed rank test.</a:t>
            </a:r>
            <a:endParaRPr lang="en-GB" sz="1100" b="0" i="0" u="none" strike="noStrike" dirty="0">
              <a:solidFill>
                <a:srgbClr val="000000"/>
              </a:solidFill>
              <a:effectLst/>
              <a:latin typeface="Calibri" panose="020F0502020204030204" pitchFamily="34" charset="0"/>
            </a:endParaRPr>
          </a:p>
          <a:p>
            <a:endParaRPr lang="en-GB" sz="1100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3B9DD41-A70F-4C18-9D03-C2423FE604D1}"/>
              </a:ext>
            </a:extLst>
          </p:cNvPr>
          <p:cNvSpPr txBox="1"/>
          <p:nvPr/>
        </p:nvSpPr>
        <p:spPr>
          <a:xfrm>
            <a:off x="7997600" y="1681282"/>
            <a:ext cx="4317999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ctr"/>
            <a:r>
              <a:rPr lang="en-US" sz="1100" dirty="0"/>
              <a:t>A3 b) </a:t>
            </a:r>
            <a:r>
              <a:rPr lang="en-US" sz="1100" u="none" strike="noStrike" dirty="0">
                <a:effectLst/>
              </a:rPr>
              <a:t>correlation between OCT CST and the average ERG all stimuli</a:t>
            </a:r>
            <a:endParaRPr lang="en-GB" sz="1100" b="0" i="0" u="none" strike="noStrike" dirty="0">
              <a:solidFill>
                <a:srgbClr val="000000"/>
              </a:solidFill>
              <a:effectLst/>
              <a:latin typeface="Calibri" panose="020F0502020204030204" pitchFamily="34" charset="0"/>
            </a:endParaRPr>
          </a:p>
          <a:p>
            <a:endParaRPr lang="en-GB" sz="1100" dirty="0"/>
          </a:p>
        </p:txBody>
      </p:sp>
    </p:spTree>
    <p:extLst>
      <p:ext uri="{BB962C8B-B14F-4D97-AF65-F5344CB8AC3E}">
        <p14:creationId xmlns:p14="http://schemas.microsoft.com/office/powerpoint/2010/main" val="24800655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7</Words>
  <Application>Microsoft Office PowerPoint</Application>
  <PresentationFormat>Widescreen</PresentationFormat>
  <Paragraphs>23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Worksheet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hompson, Dorothy</dc:creator>
  <cp:lastModifiedBy>Thompson, Dorothy</cp:lastModifiedBy>
  <cp:revision>110</cp:revision>
  <dcterms:created xsi:type="dcterms:W3CDTF">2021-02-20T10:26:49Z</dcterms:created>
  <dcterms:modified xsi:type="dcterms:W3CDTF">2021-04-22T10:50:11Z</dcterms:modified>
</cp:coreProperties>
</file>